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3DDA8-6AC2-4615-9F8C-DE2CFA2755A4}" type="datetimeFigureOut">
              <a:rPr lang="zh-CN" altLang="en-US" smtClean="0"/>
              <a:pPr/>
              <a:t>2013/8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756D26-91DA-478E-9CE7-DE08CAF1AD3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6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6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6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6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6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6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6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6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6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6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6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6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6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6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6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6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539552" y="2060848"/>
            <a:ext cx="8424936" cy="2088232"/>
          </a:xfrm>
        </p:spPr>
        <p:txBody>
          <a:bodyPr>
            <a:normAutofit fontScale="77500" lnSpcReduction="20000"/>
          </a:bodyPr>
          <a:lstStyle/>
          <a:p>
            <a:pPr algn="l"/>
            <a:r>
              <a:rPr lang="en-US" altLang="zh-CN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. Structure of novel </a:t>
            </a:r>
            <a:r>
              <a:rPr lang="en-US" altLang="zh-CN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RNA</a:t>
            </a:r>
            <a:endParaRPr lang="en-US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em-loop 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s of the potential precursors for the putative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RNAs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analyzed for RNA 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.</a:t>
            </a:r>
            <a:r>
              <a:rPr lang="en-US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P.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dicates that the novel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RNAs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specifically found in </a:t>
            </a:r>
            <a:r>
              <a:rPr lang="en-US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 P. </a:t>
            </a:r>
            <a:r>
              <a:rPr lang="en-US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rchid library. P.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dicates that the novel 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RNAs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specifically found in + </a:t>
            </a:r>
            <a:r>
              <a:rPr lang="en-US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i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chid library.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9 (</a:t>
            </a:r>
            <a:r>
              <a:rPr lang="en-US" dirty="0" smtClean="0"/>
              <a:t>novel9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9218" name="Picture 2" descr="d:\My Documents\20120924 u盘备份\印度梨形孢\预发表PLOS one\Modify according to PLOS one 7-30\Supporting information\Fig. S3 Secondary structure of miRNA precursor\Structure of novel miRNA from +P. indica library\P-indica-m0009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0 (</a:t>
            </a:r>
            <a:r>
              <a:rPr lang="en-US" dirty="0" smtClean="0"/>
              <a:t>novel10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0242" name="Picture 2" descr="d:\My Documents\20120924 u盘备份\印度梨形孢\预发表PLOS one\Modify according to PLOS one 7-30\Supporting information\Fig. S3 Secondary structure of miRNA precursor\Structure of novel miRNA from +P. indica library\P-indica-m0010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1 (</a:t>
            </a:r>
            <a:r>
              <a:rPr lang="en-US" dirty="0" smtClean="0"/>
              <a:t>novel11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1266" name="Picture 2" descr="d:\My Documents\20120924 u盘备份\印度梨形孢\预发表PLOS one\Modify according to PLOS one 7-30\Supporting information\Fig. S3 Secondary structure of miRNA precursor\Structure of novel miRNA from +P. indica library\P-indica-m001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2 (</a:t>
            </a:r>
            <a:r>
              <a:rPr lang="en-US" dirty="0" smtClean="0"/>
              <a:t>novel11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2290" name="Picture 2" descr="d:\My Documents\20120924 u盘备份\印度梨形孢\预发表PLOS one\Modify according to PLOS one 7-30\Supporting information\Fig. S3 Secondary structure of miRNA precursor\Structure of novel miRNA from +P. indica library\P-indica-m001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3 (</a:t>
            </a:r>
            <a:r>
              <a:rPr lang="en-US" dirty="0" smtClean="0"/>
              <a:t>novel13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3314" name="Picture 2" descr="d:\My Documents\20120924 u盘备份\印度梨形孢\预发表PLOS one\Modify according to PLOS one 7-30\Supporting information\Fig. S3 Secondary structure of miRNA precursor\Structure of novel miRNA from +P. indica library\P-indica-m001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4 (</a:t>
            </a:r>
            <a:r>
              <a:rPr lang="en-US" dirty="0" smtClean="0"/>
              <a:t>novel14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4338" name="Picture 2" descr="d:\My Documents\20120924 u盘备份\印度梨形孢\预发表PLOS one\Modify according to PLOS one 7-30\Supporting information\Fig. S3 Secondary structure of miRNA precursor\Structure of novel miRNA from +P. indica library\P-indica-m001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5 (</a:t>
            </a:r>
            <a:r>
              <a:rPr lang="en-US" dirty="0" smtClean="0"/>
              <a:t>novel15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5362" name="Picture 2" descr="d:\My Documents\20120924 u盘备份\印度梨形孢\预发表PLOS one\Modify according to PLOS one 7-30\Supporting information\Fig. S3 Secondary structure of miRNA precursor\Structure of novel miRNA from +P. indica library\P-indica-m001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6 (</a:t>
            </a:r>
            <a:r>
              <a:rPr lang="en-US" dirty="0" smtClean="0"/>
              <a:t>novel16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6386" name="Picture 2" descr="d:\My Documents\20120924 u盘备份\印度梨形孢\预发表PLOS one\Modify according to PLOS one 7-30\Supporting information\Fig. S3 Secondary structure of miRNA precursor\Structure of novel miRNA from +P. indica library\P-indica-m001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7 (</a:t>
            </a:r>
            <a:r>
              <a:rPr lang="en-US" dirty="0" smtClean="0"/>
              <a:t>novel17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7410" name="Picture 2" descr="d:\My Documents\20120924 u盘备份\印度梨形孢\预发表PLOS one\Modify according to PLOS one 7-30\Supporting information\Fig. S3 Secondary structure of miRNA precursor\Structure of novel miRNA from +P. indica library\P-indica-m0017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8 (</a:t>
            </a:r>
            <a:r>
              <a:rPr lang="en-US" dirty="0" smtClean="0"/>
              <a:t>novel18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8434" name="Picture 2" descr="d:\My Documents\20120924 u盘备份\印度梨形孢\预发表PLOS one\Modify according to PLOS one 7-30\Supporting information\Fig. S3 Secondary structure of miRNA precursor\Structure of novel miRNA from +P. indica library\P-indica-m0018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My Documents\20120924 u盘备份\印度梨形孢\预发表PLOS one\Modify according to PLOS one 7-30\Supporting information\Fig. S3 Secondary structure of miRNA precursor\Structure of novel miRNA from +P. indica library\P-indica-m000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28860" y="1857364"/>
            <a:ext cx="4305300" cy="4305300"/>
          </a:xfrm>
          <a:prstGeom prst="rect">
            <a:avLst/>
          </a:prstGeom>
          <a:noFill/>
        </p:spPr>
      </p:pic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1 </a:t>
            </a:r>
            <a:r>
              <a:rPr lang="en-US" dirty="0" smtClean="0"/>
              <a:t>(novel1 )</a:t>
            </a:r>
            <a:endParaRPr lang="zh-CN" alt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19 (</a:t>
            </a:r>
            <a:r>
              <a:rPr lang="en-US" dirty="0" smtClean="0"/>
              <a:t>novel19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19458" name="Picture 2" descr="d:\My Documents\20120924 u盘备份\印度梨形孢\预发表PLOS one\Modify according to PLOS one 7-30\Supporting information\Fig. S3 Secondary structure of miRNA precursor\Structure of novel miRNA from +P. indica library\P-indica-m0019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0 (</a:t>
            </a:r>
            <a:r>
              <a:rPr lang="en-US" dirty="0" smtClean="0"/>
              <a:t>novel20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0482" name="Picture 2" descr="d:\My Documents\20120924 u盘备份\印度梨形孢\预发表PLOS one\Modify according to PLOS one 7-30\Supporting information\Fig. S3 Secondary structure of miRNA precursor\Structure of novel miRNA from +P. indica library\P-indica-m0020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1 (</a:t>
            </a:r>
            <a:r>
              <a:rPr lang="en-US" dirty="0" smtClean="0"/>
              <a:t>novel21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1506" name="Picture 2" descr="d:\My Documents\20120924 u盘备份\印度梨形孢\预发表PLOS one\Modify according to PLOS one 7-30\Supporting information\Fig. S3 Secondary structure of miRNA precursor\Structure of novel miRNA from +P. indica library\P-indica-m002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2 (</a:t>
            </a:r>
            <a:r>
              <a:rPr lang="en-US" dirty="0" smtClean="0"/>
              <a:t>novel22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2530" name="Picture 2" descr="d:\My Documents\20120924 u盘备份\印度梨形孢\预发表PLOS one\Modify according to PLOS one 7-30\Supporting information\Fig. S3 Secondary structure of miRNA precursor\Structure of novel miRNA from +P. indica library\P-indica-m002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3 (</a:t>
            </a:r>
            <a:r>
              <a:rPr lang="en-US" dirty="0" smtClean="0"/>
              <a:t>novel23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3555" name="Picture 3" descr="d:\My Documents\20120924 u盘备份\印度梨形孢\预发表PLOS one\Modify according to PLOS one 7-30\Supporting information\Fig. S3 Secondary structure of miRNA precursor\Structure of novel miRNA from +P. indica library\P-indica-m002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4 (</a:t>
            </a:r>
            <a:r>
              <a:rPr lang="en-US" dirty="0" smtClean="0"/>
              <a:t>novel24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4578" name="Picture 2" descr="d:\My Documents\20120924 u盘备份\印度梨形孢\预发表PLOS one\Modify according to PLOS one 7-30\Supporting information\Fig. S3 Secondary structure of miRNA precursor\Structure of novel miRNA from +P. indica library\P-indica-m002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5 (</a:t>
            </a:r>
            <a:r>
              <a:rPr lang="en-US" dirty="0" smtClean="0"/>
              <a:t>novel25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5602" name="Picture 2" descr="d:\My Documents\20120924 u盘备份\印度梨形孢\预发表PLOS one\Modify according to PLOS one 7-30\Supporting information\Fig. S3 Secondary structure of miRNA precursor\Structure of novel miRNA from +P. indica library\P-indica-m002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6 (</a:t>
            </a:r>
            <a:r>
              <a:rPr lang="en-US" dirty="0" smtClean="0"/>
              <a:t>novel26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6626" name="Picture 2" descr="d:\My Documents\20120924 u盘备份\印度梨形孢\预发表PLOS one\Modify according to PLOS one 7-30\Supporting information\Fig. S3 Secondary structure of miRNA precursor\Structure of novel miRNA from +P. indica library\P-indica-m002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7 (</a:t>
            </a:r>
            <a:r>
              <a:rPr lang="en-US" dirty="0" smtClean="0"/>
              <a:t>novel27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7650" name="Picture 2" descr="d:\My Documents\20120924 u盘备份\印度梨形孢\预发表PLOS one\Modify according to PLOS one 7-30\Supporting information\Fig. S3 Secondary structure of miRNA precursor\Structure of novel miRNA from +P. indica library\P-indica-m0027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8 (</a:t>
            </a:r>
            <a:r>
              <a:rPr lang="en-US" dirty="0" smtClean="0"/>
              <a:t>novel28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8674" name="Picture 2" descr="d:\My Documents\20120924 u盘备份\印度梨形孢\预发表PLOS one\Modify according to PLOS one 7-30\Supporting information\Fig. S3 Secondary structure of miRNA precursor\Structure of novel miRNA from +P. indica library\P-indica-m0028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2 (</a:t>
            </a:r>
            <a:r>
              <a:rPr lang="en-US" dirty="0"/>
              <a:t>novel2</a:t>
            </a:r>
            <a:r>
              <a:rPr lang="en-US" dirty="0" smtClean="0"/>
              <a:t>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050" name="Picture 2" descr="d:\My Documents\20120924 u盘备份\印度梨形孢\预发表PLOS one\Modify according to PLOS one 7-30\Supporting information\Fig. S3 Secondary structure of miRNA precursor\Structure of novel miRNA from +P. indica library\P-indica-m000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5984" y="200024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29 (</a:t>
            </a:r>
            <a:r>
              <a:rPr lang="en-US" dirty="0" smtClean="0"/>
              <a:t>novel29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29698" name="Picture 2" descr="d:\My Documents\20120924 u盘备份\印度梨形孢\预发表PLOS one\Modify according to PLOS one 7-30\Supporting information\Fig. S3 Secondary structure of miRNA precursor\Structure of novel miRNA from +P. indica library\P-indica-m0029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30 (</a:t>
            </a:r>
            <a:r>
              <a:rPr lang="en-US" dirty="0" smtClean="0"/>
              <a:t>novel30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0722" name="Picture 2" descr="d:\My Documents\20120924 u盘备份\印度梨形孢\预发表PLOS one\Modify according to PLOS one 7-30\Supporting information\Fig. S3 Secondary structure of miRNA precursor\Structure of novel miRNA from +P. indica library\P-indica-m0030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31 (</a:t>
            </a:r>
            <a:r>
              <a:rPr lang="en-US" dirty="0" smtClean="0"/>
              <a:t>novel31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1746" name="Picture 2" descr="d:\My Documents\20120924 u盘备份\印度梨形孢\预发表PLOS one\Modify according to PLOS one 7-30\Supporting information\Fig. S3 Secondary structure of miRNA precursor\Structure of novel miRNA from +P. indica library\P-indica-m003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1 (</a:t>
            </a:r>
            <a:r>
              <a:rPr lang="en-US" dirty="0" smtClean="0"/>
              <a:t>novel32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2770" name="Picture 2" descr="d:\My Documents\20120924 u盘备份\印度梨形孢\预发表PLOS one\Modify according to PLOS one 7-30\Supporting information\Fig. S3 Secondary structure of miRNA precursor\Structure of novel miRNA from control library\no-P-indica-m000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2  (</a:t>
            </a:r>
            <a:r>
              <a:rPr lang="en-US" dirty="0" smtClean="0"/>
              <a:t>novel2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3794" name="Picture 2" descr="d:\My Documents\20120924 u盘备份\印度梨形孢\预发表PLOS one\Modify according to PLOS one 7-30\Supporting information\Fig. S3 Secondary structure of miRNA precursor\Structure of novel miRNA from control library\no-P-indica-m000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3 (</a:t>
            </a:r>
            <a:r>
              <a:rPr lang="en-US" dirty="0" smtClean="0"/>
              <a:t>novel33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4818" name="Picture 2" descr="d:\My Documents\20120924 u盘备份\印度梨形孢\预发表PLOS one\Modify according to PLOS one 7-30\Supporting information\Fig. S3 Secondary structure of miRNA precursor\Structure of novel miRNA from control library\no-P-indica-m000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4 (</a:t>
            </a:r>
            <a:r>
              <a:rPr lang="en-US" dirty="0" smtClean="0"/>
              <a:t>novel34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5842" name="Picture 2" descr="d:\My Documents\20120924 u盘备份\印度梨形孢\预发表PLOS one\Modify according to PLOS one 7-30\Supporting information\Fig. S3 Secondary structure of miRNA precursor\Structure of novel miRNA from control library\no-P-indica-m000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5 (</a:t>
            </a:r>
            <a:r>
              <a:rPr lang="en-US" dirty="0" smtClean="0"/>
              <a:t>novel35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6866" name="Picture 2" descr="d:\My Documents\20120924 u盘备份\印度梨形孢\预发表PLOS one\Modify according to PLOS one 7-30\Supporting information\Fig. S3 Secondary structure of miRNA precursor\Structure of novel miRNA from control library\no-P-indica-m000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6 (</a:t>
            </a:r>
            <a:r>
              <a:rPr lang="en-US" dirty="0" smtClean="0"/>
              <a:t>novel36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7890" name="Picture 2" descr="d:\My Documents\20120924 u盘备份\印度梨形孢\预发表PLOS one\Modify according to PLOS one 7-30\Supporting information\Fig. S3 Secondary structure of miRNA precursor\Structure of novel miRNA from control library\no-P-indica-m000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7 (</a:t>
            </a:r>
            <a:r>
              <a:rPr lang="en-US" dirty="0" smtClean="0"/>
              <a:t>novel37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8914" name="Picture 2" descr="d:\My Documents\20120924 u盘备份\印度梨形孢\预发表PLOS one\Modify according to PLOS one 7-30\Supporting information\Fig. S3 Secondary structure of miRNA precursor\Structure of novel miRNA from control library\no-P-indica-m0007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3 (</a:t>
            </a:r>
            <a:r>
              <a:rPr lang="en-US" dirty="0" smtClean="0"/>
              <a:t>novel3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074" name="Picture 2" descr="d:\My Documents\20120924 u盘备份\印度梨形孢\预发表PLOS one\Modify according to PLOS one 7-30\Supporting information\Fig. S3 Secondary structure of miRNA precursor\Structure of novel miRNA from +P. indica library\P-indica-m000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57422" y="2071678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8 (</a:t>
            </a:r>
            <a:r>
              <a:rPr lang="en-US" dirty="0" smtClean="0"/>
              <a:t>novel38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39938" name="Picture 2" descr="d:\My Documents\20120924 u盘备份\印度梨形孢\预发表PLOS one\Modify according to PLOS one 7-30\Supporting information\Fig. S3 Secondary structure of miRNA precursor\Structure of novel miRNA from control library\no-P-indica-m0008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09 (</a:t>
            </a:r>
            <a:r>
              <a:rPr lang="en-US" dirty="0" smtClean="0"/>
              <a:t>novel39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0962" name="Picture 2" descr="d:\My Documents\20120924 u盘备份\印度梨形孢\预发表PLOS one\Modify according to PLOS one 7-30\Supporting information\Fig. S3 Secondary structure of miRNA precursor\Structure of novel miRNA from control library\no-P-indica-m0009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0 (</a:t>
            </a:r>
            <a:r>
              <a:rPr lang="en-US" dirty="0" smtClean="0"/>
              <a:t>novel8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1986" name="Picture 2" descr="d:\My Documents\20120924 u盘备份\印度梨形孢\预发表PLOS one\Modify according to PLOS one 7-30\Supporting information\Fig. S3 Secondary structure of miRNA precursor\Structure of novel miRNA from control library\no-P-indica-m0010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1 (</a:t>
            </a:r>
            <a:r>
              <a:rPr lang="en-US" dirty="0" smtClean="0"/>
              <a:t>novel40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3010" name="Picture 2" descr="d:\My Documents\20120924 u盘备份\印度梨形孢\预发表PLOS one\Modify according to PLOS one 7-30\Supporting information\Fig. S3 Secondary structure of miRNA precursor\Structure of novel miRNA from control library\no-P-indica-m001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2 (</a:t>
            </a:r>
            <a:r>
              <a:rPr lang="en-US" dirty="0" smtClean="0"/>
              <a:t>novel41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4034" name="Picture 2" descr="d:\My Documents\20120924 u盘备份\印度梨形孢\预发表PLOS one\Modify according to PLOS one 7-30\Supporting information\Fig. S3 Secondary structure of miRNA precursor\Structure of novel miRNA from control library\no-P-indica-m001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3 (</a:t>
            </a:r>
            <a:r>
              <a:rPr lang="en-US" dirty="0" smtClean="0"/>
              <a:t>novel11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5058" name="Picture 2" descr="d:\My Documents\20120924 u盘备份\印度梨形孢\预发表PLOS one\Modify according to PLOS one 7-30\Supporting information\Fig. S3 Secondary structure of miRNA precursor\Structure of novel miRNA from control library\no-P-indica-m001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4 (</a:t>
            </a:r>
            <a:r>
              <a:rPr lang="en-US" dirty="0" smtClean="0"/>
              <a:t>novel12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6082" name="Picture 2" descr="d:\My Documents\20120924 u盘备份\印度梨形孢\预发表PLOS one\Modify according to PLOS one 7-30\Supporting information\Fig. S3 Secondary structure of miRNA precursor\Structure of novel miRNA from control library\no-P-indica-m001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5 (</a:t>
            </a:r>
            <a:r>
              <a:rPr lang="en-US" dirty="0" smtClean="0"/>
              <a:t>novel17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7106" name="Picture 2" descr="d:\My Documents\20120924 u盘备份\印度梨形孢\预发表PLOS one\Modify according to PLOS one 7-30\Supporting information\Fig. S3 Secondary structure of miRNA precursor\Structure of novel miRNA from control library\no-P-indica-m001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6 (</a:t>
            </a:r>
            <a:r>
              <a:rPr lang="en-US" dirty="0" smtClean="0"/>
              <a:t>novel42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8130" name="Picture 2" descr="d:\My Documents\20120924 u盘备份\印度梨形孢\预发表PLOS one\Modify according to PLOS one 7-30\Supporting information\Fig. S3 Secondary structure of miRNA precursor\Structure of novel miRNA from control library\no-P-indica-m001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7 (</a:t>
            </a:r>
            <a:r>
              <a:rPr lang="en-US" dirty="0" smtClean="0"/>
              <a:t>novel43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9154" name="Picture 2" descr="d:\My Documents\20120924 u盘备份\印度梨形孢\预发表PLOS one\Modify according to PLOS one 7-30\Supporting information\Fig. S3 Secondary structure of miRNA precursor\Structure of novel miRNA from control library\no-P-indica-m0017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4 (</a:t>
            </a:r>
            <a:r>
              <a:rPr lang="en-US" dirty="0" smtClean="0"/>
              <a:t>novel4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4098" name="Picture 2" descr="d:\My Documents\20120924 u盘备份\印度梨形孢\预发表PLOS one\Modify according to PLOS one 7-30\Supporting information\Fig. S3 Secondary structure of miRNA precursor\Structure of novel miRNA from +P. indica library\P-indica-m000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5984" y="2071678"/>
            <a:ext cx="4305300" cy="4305300"/>
          </a:xfrm>
          <a:prstGeom prst="rect">
            <a:avLst/>
          </a:prstGeom>
          <a:noFill/>
        </p:spPr>
      </p:pic>
      <p:pic>
        <p:nvPicPr>
          <p:cNvPr id="4099" name="Picture 3" descr="d:\My Documents\20120924 u盘备份\印度梨形孢\预发表PLOS one\Modify according to PLOS one 7-30\Supporting information\Fig. S3 Secondary structure of miRNA precursor\Structure of novel miRNA from +P. indica library\P-indica-m000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8 (</a:t>
            </a:r>
            <a:r>
              <a:rPr lang="en-US" dirty="0" smtClean="0"/>
              <a:t>novel44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0178" name="Picture 2" descr="d:\My Documents\20120924 u盘备份\印度梨形孢\预发表PLOS one\Modify according to PLOS one 7-30\Supporting information\Fig. S3 Secondary structure of miRNA precursor\Structure of novel miRNA from control library\no-P-indica-m0018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19 (</a:t>
            </a:r>
            <a:r>
              <a:rPr lang="en-US" dirty="0" smtClean="0"/>
              <a:t>novel21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1202" name="Picture 2" descr="d:\My Documents\20120924 u盘备份\印度梨形孢\预发表PLOS one\Modify according to PLOS one 7-30\Supporting information\Fig. S3 Secondary structure of miRNA precursor\Structure of novel miRNA from control library\no-P-indica-m0019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0 (</a:t>
            </a:r>
            <a:r>
              <a:rPr lang="en-US" dirty="0" smtClean="0"/>
              <a:t>novel45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2226" name="Picture 2" descr="d:\My Documents\20120924 u盘备份\印度梨形孢\预发表PLOS one\Modify according to PLOS one 7-30\Supporting information\Fig. S3 Secondary structure of miRNA precursor\Structure of novel miRNA from control library\no-P-indica-m0020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1  (</a:t>
            </a:r>
            <a:r>
              <a:rPr lang="en-US" dirty="0" smtClean="0"/>
              <a:t>novel46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3250" name="Picture 2" descr="d:\My Documents\20120924 u盘备份\印度梨形孢\预发表PLOS one\Modify according to PLOS one 7-30\Supporting information\Fig. S3 Secondary structure of miRNA precursor\Structure of novel miRNA from control library\no-P-indica-m0021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2 (</a:t>
            </a:r>
            <a:r>
              <a:rPr lang="en-US" dirty="0" smtClean="0"/>
              <a:t>novel47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4274" name="Picture 2" descr="d:\My Documents\20120924 u盘备份\印度梨形孢\预发表PLOS one\Modify according to PLOS one 7-30\Supporting information\Fig. S3 Secondary structure of miRNA precursor\Structure of novel miRNA from control library\no-P-indica-m0022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3  (</a:t>
            </a:r>
            <a:r>
              <a:rPr lang="en-US" dirty="0" smtClean="0"/>
              <a:t>novel48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5298" name="Picture 2" descr="d:\My Documents\20120924 u盘备份\印度梨形孢\预发表PLOS one\Modify according to PLOS one 7-30\Supporting information\Fig. S3 Secondary structure of miRNA precursor\Structure of novel miRNA from control library\no-P-indica-m0023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4 (</a:t>
            </a:r>
            <a:r>
              <a:rPr lang="en-US" dirty="0" smtClean="0"/>
              <a:t>novel49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6322" name="Picture 2" descr="d:\My Documents\20120924 u盘备份\印度梨形孢\预发表PLOS one\Modify according to PLOS one 7-30\Supporting information\Fig. S3 Secondary structure of miRNA precursor\Structure of novel miRNA from control library\no-P-indica-m0024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5 (</a:t>
            </a:r>
            <a:r>
              <a:rPr lang="en-US" dirty="0" smtClean="0"/>
              <a:t>novel50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7346" name="Picture 2" descr="d:\My Documents\20120924 u盘备份\印度梨形孢\预发表PLOS one\Modify according to PLOS one 7-30\Supporting information\Fig. S3 Secondary structure of miRNA precursor\Structure of novel miRNA from control library\no-P-indica-m002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no-P-indica-m0026 </a:t>
            </a:r>
            <a:r>
              <a:rPr lang="en-US" altLang="zh-CN" smtClean="0"/>
              <a:t>(</a:t>
            </a:r>
            <a:r>
              <a:rPr lang="en-US" smtClean="0"/>
              <a:t>novel51</a:t>
            </a:r>
            <a:r>
              <a:rPr lang="en-US" altLang="zh-CN" smtClean="0"/>
              <a:t>)</a:t>
            </a:r>
            <a:endParaRPr lang="zh-CN" altLang="en-US" dirty="0"/>
          </a:p>
        </p:txBody>
      </p:sp>
      <p:pic>
        <p:nvPicPr>
          <p:cNvPr id="58370" name="Picture 2" descr="d:\My Documents\20120924 u盘备份\印度梨形孢\预发表PLOS one\Modify according to PLOS one 7-30\Supporting information\Fig. S3 Secondary structure of miRNA precursor\Structure of novel miRNA from control library\no-P-indica-m002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5 (</a:t>
            </a:r>
            <a:r>
              <a:rPr lang="en-US" dirty="0" smtClean="0"/>
              <a:t>novel5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5122" name="Picture 2" descr="d:\My Documents\20120924 u盘备份\印度梨形孢\预发表PLOS one\Modify according to PLOS one 7-30\Supporting information\Fig. S3 Secondary structure of miRNA precursor\Structure of novel miRNA from +P. indica library\P-indica-m0005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6 (</a:t>
            </a:r>
            <a:r>
              <a:rPr lang="en-US" dirty="0" smtClean="0"/>
              <a:t>novel6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6146" name="Picture 2" descr="d:\My Documents\20120924 u盘备份\印度梨形孢\预发表PLOS one\Modify according to PLOS one 7-30\Supporting information\Fig. S3 Secondary structure of miRNA precursor\Structure of novel miRNA from +P. indica library\P-indica-m0006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7 (</a:t>
            </a:r>
            <a:r>
              <a:rPr lang="en-US" dirty="0" smtClean="0"/>
              <a:t>novel7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7170" name="Picture 2" descr="d:\My Documents\20120924 u盘备份\印度梨形孢\预发表PLOS one\Modify according to PLOS one 7-30\Supporting information\Fig. S3 Secondary structure of miRNA precursor\Structure of novel miRNA from +P. indica library\P-indica-m0007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 smtClean="0"/>
              <a:t>P-indica-m0008 (</a:t>
            </a:r>
            <a:r>
              <a:rPr lang="en-US" dirty="0" smtClean="0"/>
              <a:t>novel8 </a:t>
            </a:r>
            <a:r>
              <a:rPr lang="en-US" altLang="zh-CN" dirty="0" smtClean="0"/>
              <a:t>)</a:t>
            </a:r>
            <a:endParaRPr lang="zh-CN" altLang="en-US" dirty="0"/>
          </a:p>
        </p:txBody>
      </p:sp>
      <p:pic>
        <p:nvPicPr>
          <p:cNvPr id="8194" name="Picture 2" descr="d:\My Documents\20120924 u盘备份\印度梨形孢\预发表PLOS one\Modify according to PLOS one 7-30\Supporting information\Fig. S3 Secondary structure of miRNA precursor\Structure of novel miRNA from +P. indica library\P-indica-m0008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19350" y="1276350"/>
            <a:ext cx="4305300" cy="43053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90</Words>
  <Application>Microsoft Office PowerPoint</Application>
  <PresentationFormat>如螢幕大小 (4:3)</PresentationFormat>
  <Paragraphs>59</Paragraphs>
  <Slides>58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8</vt:i4>
      </vt:variant>
    </vt:vector>
  </HeadingPairs>
  <TitlesOfParts>
    <vt:vector size="63" baseType="lpstr">
      <vt:lpstr>宋体</vt:lpstr>
      <vt:lpstr>Arial</vt:lpstr>
      <vt:lpstr>Calibri</vt:lpstr>
      <vt:lpstr>Times New Roman</vt:lpstr>
      <vt:lpstr>Office 主题</vt:lpstr>
      <vt:lpstr>PowerPoint 簡報</vt:lpstr>
      <vt:lpstr>P-indica-m0001 (novel1 )</vt:lpstr>
      <vt:lpstr>P-indica-m0002 (novel2 )</vt:lpstr>
      <vt:lpstr>P-indica-m0003 (novel3 )</vt:lpstr>
      <vt:lpstr>P-indica-m0004 (novel4 )</vt:lpstr>
      <vt:lpstr>P-indica-m0005 (novel5 )</vt:lpstr>
      <vt:lpstr>P-indica-m0006 (novel6 )</vt:lpstr>
      <vt:lpstr>P-indica-m0007 (novel7 )</vt:lpstr>
      <vt:lpstr>P-indica-m0008 (novel8 )</vt:lpstr>
      <vt:lpstr>P-indica-m0009 (novel9 )</vt:lpstr>
      <vt:lpstr>P-indica-m0010 (novel10 )</vt:lpstr>
      <vt:lpstr>P-indica-m0011 (novel11 )</vt:lpstr>
      <vt:lpstr>P-indica-m0012 (novel11 )</vt:lpstr>
      <vt:lpstr>P-indica-m0013 (novel13 )</vt:lpstr>
      <vt:lpstr>P-indica-m0014 (novel14 )</vt:lpstr>
      <vt:lpstr>P-indica-m0015 (novel15 )</vt:lpstr>
      <vt:lpstr>P-indica-m0016 (novel16 )</vt:lpstr>
      <vt:lpstr>P-indica-m0017 (novel17 )</vt:lpstr>
      <vt:lpstr>P-indica-m0018 (novel18 )</vt:lpstr>
      <vt:lpstr>P-indica-m0019 (novel19 )</vt:lpstr>
      <vt:lpstr>P-indica-m0020 (novel20 )</vt:lpstr>
      <vt:lpstr>P-indica-m0021 (novel21 )</vt:lpstr>
      <vt:lpstr>P-indica-m0022 (novel22 )</vt:lpstr>
      <vt:lpstr>P-indica-m0023 (novel23 )</vt:lpstr>
      <vt:lpstr>P-indica-m0024 (novel24 )</vt:lpstr>
      <vt:lpstr>P-indica-m0025 (novel25 )</vt:lpstr>
      <vt:lpstr>P-indica-m0026 (novel26 )</vt:lpstr>
      <vt:lpstr>P-indica-m0027 (novel27 )</vt:lpstr>
      <vt:lpstr>P-indica-m0028 (novel28 )</vt:lpstr>
      <vt:lpstr>P-indica-m0029 (novel29 )</vt:lpstr>
      <vt:lpstr>P-indica-m0030 (novel30 )</vt:lpstr>
      <vt:lpstr>P-indica-m0031 (novel31 )</vt:lpstr>
      <vt:lpstr>no-P-indica-m0001 (novel32 )</vt:lpstr>
      <vt:lpstr>no-P-indica-m0002  (novel2 )</vt:lpstr>
      <vt:lpstr>no-P-indica-m0003 (novel33 )</vt:lpstr>
      <vt:lpstr>no-P-indica-m0004 (novel34 )</vt:lpstr>
      <vt:lpstr>no-P-indica-m0005 (novel35 )</vt:lpstr>
      <vt:lpstr>no-P-indica-m0006 (novel36 )</vt:lpstr>
      <vt:lpstr>no-P-indica-m0007 (novel37 )</vt:lpstr>
      <vt:lpstr>no-P-indica-m0008 (novel38)</vt:lpstr>
      <vt:lpstr>no-P-indica-m0009 (novel39 )</vt:lpstr>
      <vt:lpstr>no-P-indica-m0010 (novel8 )</vt:lpstr>
      <vt:lpstr>no-P-indica-m0011 (novel40 )</vt:lpstr>
      <vt:lpstr>no-P-indica-m0012 (novel41)</vt:lpstr>
      <vt:lpstr>no-P-indica-m0013 (novel11)</vt:lpstr>
      <vt:lpstr>no-P-indica-m0014 (novel12)</vt:lpstr>
      <vt:lpstr>no-P-indica-m0015 (novel17)</vt:lpstr>
      <vt:lpstr>no-P-indica-m0016 (novel42)</vt:lpstr>
      <vt:lpstr>no-P-indica-m0017 (novel43)</vt:lpstr>
      <vt:lpstr>no-P-indica-m0018 (novel44)</vt:lpstr>
      <vt:lpstr>no-P-indica-m0019 (novel21)</vt:lpstr>
      <vt:lpstr>no-P-indica-m0020 (novel45)</vt:lpstr>
      <vt:lpstr>no-P-indica-m0021  (novel46)</vt:lpstr>
      <vt:lpstr>no-P-indica-m0022 (novel47)</vt:lpstr>
      <vt:lpstr>no-P-indica-m0023  (novel48)</vt:lpstr>
      <vt:lpstr>no-P-indica-m0024 (novel49)</vt:lpstr>
      <vt:lpstr>no-P-indica-m0025 (novel50)</vt:lpstr>
      <vt:lpstr>no-P-indica-m0026 (novel51)</vt:lpstr>
    </vt:vector>
  </TitlesOfParts>
  <Company>Legend (Beijing) Limite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ructure of novel miRNA</dc:title>
  <dc:creator>Lenovo User</dc:creator>
  <cp:lastModifiedBy>水月</cp:lastModifiedBy>
  <cp:revision>12</cp:revision>
  <dcterms:created xsi:type="dcterms:W3CDTF">2013-08-12T15:02:37Z</dcterms:created>
  <dcterms:modified xsi:type="dcterms:W3CDTF">2013-08-22T12:00:12Z</dcterms:modified>
</cp:coreProperties>
</file>